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30" d="100"/>
          <a:sy n="130" d="100"/>
        </p:scale>
        <p:origin x="-942" y="-184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537C7-4B9E-4B90-818F-657D0DB46BA1}" type="datetimeFigureOut">
              <a:rPr lang="en-GB" smtClean="0"/>
              <a:t>25/06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325A7-4E28-48FC-98C0-3D1A5950B0D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4590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537C7-4B9E-4B90-818F-657D0DB46BA1}" type="datetimeFigureOut">
              <a:rPr lang="en-GB" smtClean="0"/>
              <a:t>25/06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325A7-4E28-48FC-98C0-3D1A5950B0D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81643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537C7-4B9E-4B90-818F-657D0DB46BA1}" type="datetimeFigureOut">
              <a:rPr lang="en-GB" smtClean="0"/>
              <a:t>25/06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325A7-4E28-48FC-98C0-3D1A5950B0D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24255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537C7-4B9E-4B90-818F-657D0DB46BA1}" type="datetimeFigureOut">
              <a:rPr lang="en-GB" smtClean="0"/>
              <a:t>25/06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325A7-4E28-48FC-98C0-3D1A5950B0D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59324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537C7-4B9E-4B90-818F-657D0DB46BA1}" type="datetimeFigureOut">
              <a:rPr lang="en-GB" smtClean="0"/>
              <a:t>25/06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325A7-4E28-48FC-98C0-3D1A5950B0D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56211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537C7-4B9E-4B90-818F-657D0DB46BA1}" type="datetimeFigureOut">
              <a:rPr lang="en-GB" smtClean="0"/>
              <a:t>25/06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325A7-4E28-48FC-98C0-3D1A5950B0D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22767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537C7-4B9E-4B90-818F-657D0DB46BA1}" type="datetimeFigureOut">
              <a:rPr lang="en-GB" smtClean="0"/>
              <a:t>25/06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325A7-4E28-48FC-98C0-3D1A5950B0D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170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537C7-4B9E-4B90-818F-657D0DB46BA1}" type="datetimeFigureOut">
              <a:rPr lang="en-GB" smtClean="0"/>
              <a:t>25/06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325A7-4E28-48FC-98C0-3D1A5950B0D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198526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537C7-4B9E-4B90-818F-657D0DB46BA1}" type="datetimeFigureOut">
              <a:rPr lang="en-GB" smtClean="0"/>
              <a:t>25/06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325A7-4E28-48FC-98C0-3D1A5950B0D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75849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537C7-4B9E-4B90-818F-657D0DB46BA1}" type="datetimeFigureOut">
              <a:rPr lang="en-GB" smtClean="0"/>
              <a:t>25/06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325A7-4E28-48FC-98C0-3D1A5950B0D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376833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6537C7-4B9E-4B90-818F-657D0DB46BA1}" type="datetimeFigureOut">
              <a:rPr lang="en-GB" smtClean="0"/>
              <a:t>25/06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C325A7-4E28-48FC-98C0-3D1A5950B0D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8597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6537C7-4B9E-4B90-818F-657D0DB46BA1}" type="datetimeFigureOut">
              <a:rPr lang="en-GB" smtClean="0"/>
              <a:t>25/06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C325A7-4E28-48FC-98C0-3D1A5950B0D9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39077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tiff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ZoneTexte 12"/>
          <p:cNvSpPr txBox="1"/>
          <p:nvPr/>
        </p:nvSpPr>
        <p:spPr>
          <a:xfrm>
            <a:off x="596560" y="4455668"/>
            <a:ext cx="831324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B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GB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US expression patterns in tissues of 4-month-old </a:t>
            </a:r>
            <a:r>
              <a:rPr lang="en-GB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oplar grown in </a:t>
            </a:r>
            <a:r>
              <a:rPr lang="en-GB" sz="12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 greenhouse.</a:t>
            </a:r>
            <a:r>
              <a:rPr lang="fr-BE" sz="1200" i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fr-BE" sz="1200" i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fr-B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p</a:t>
            </a:r>
            <a:r>
              <a:rPr lang="fr-BE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GT72A2</a:t>
            </a:r>
            <a:r>
              <a:rPr lang="fr-B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fr-BE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US, </a:t>
            </a:r>
            <a:r>
              <a:rPr lang="fr-B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oung</a:t>
            </a:r>
            <a:r>
              <a:rPr lang="fr-B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leaf. </a:t>
            </a:r>
          </a:p>
          <a:p>
            <a:r>
              <a:rPr lang="fr-B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-c)</a:t>
            </a:r>
            <a:r>
              <a:rPr lang="fr-B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p</a:t>
            </a:r>
            <a:r>
              <a:rPr lang="fr-BE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GT72AZ1</a:t>
            </a:r>
            <a:r>
              <a:rPr lang="fr-B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fr-BE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US. </a:t>
            </a:r>
            <a:r>
              <a:rPr lang="fr-B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fr-B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Young leaf </a:t>
            </a:r>
            <a:r>
              <a:rPr lang="fr-B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fr-B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x). (c) Y</a:t>
            </a:r>
            <a:r>
              <a:rPr lang="fr-B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ung </a:t>
            </a:r>
            <a:r>
              <a:rPr lang="fr-BE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oot</a:t>
            </a:r>
            <a:r>
              <a:rPr lang="fr-B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fr-B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0x). </a:t>
            </a:r>
          </a:p>
          <a:p>
            <a:r>
              <a:rPr lang="fr-B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d) p</a:t>
            </a:r>
            <a:r>
              <a:rPr lang="fr-BE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GT72AZ2</a:t>
            </a:r>
            <a:r>
              <a:rPr lang="fr-B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fr-BE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US</a:t>
            </a:r>
            <a:r>
              <a:rPr lang="fr-B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fr-B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young</a:t>
            </a:r>
            <a:r>
              <a:rPr lang="fr-B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B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ot</a:t>
            </a:r>
            <a:r>
              <a:rPr lang="fr-B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B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20x</a:t>
            </a:r>
            <a:r>
              <a:rPr lang="fr-B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</a:p>
          <a:p>
            <a:r>
              <a:rPr lang="fr-B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(e) p</a:t>
            </a:r>
            <a:r>
              <a:rPr lang="fr-BE" sz="1200" i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UGT72B39::GUS</a:t>
            </a:r>
            <a:r>
              <a:rPr lang="fr-BE" sz="12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fr-B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BE" sz="1200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oung</a:t>
            </a:r>
            <a:r>
              <a:rPr lang="fr-BE" sz="1200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leaf (10x)</a:t>
            </a:r>
            <a:endParaRPr lang="fr-BE" sz="1200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Groupe 8"/>
          <p:cNvGrpSpPr/>
          <p:nvPr/>
        </p:nvGrpSpPr>
        <p:grpSpPr>
          <a:xfrm>
            <a:off x="1376611" y="580352"/>
            <a:ext cx="2077226" cy="1642927"/>
            <a:chOff x="323322" y="830671"/>
            <a:chExt cx="2077226" cy="164292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32"/>
            <a:stretch/>
          </p:blipFill>
          <p:spPr>
            <a:xfrm>
              <a:off x="399783" y="837350"/>
              <a:ext cx="2000765" cy="1636248"/>
            </a:xfrm>
            <a:prstGeom prst="rect">
              <a:avLst/>
            </a:prstGeom>
          </p:spPr>
        </p:pic>
        <p:sp>
          <p:nvSpPr>
            <p:cNvPr id="8" name="ZoneTexte 7"/>
            <p:cNvSpPr txBox="1"/>
            <p:nvPr/>
          </p:nvSpPr>
          <p:spPr>
            <a:xfrm>
              <a:off x="323322" y="830671"/>
              <a:ext cx="391952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BE" sz="1350" dirty="0" smtClean="0"/>
                <a:t>(a)</a:t>
              </a:r>
              <a:endParaRPr lang="fr-BE" sz="1350" dirty="0"/>
            </a:p>
          </p:txBody>
        </p:sp>
      </p:grpSp>
      <p:grpSp>
        <p:nvGrpSpPr>
          <p:cNvPr id="2" name="Groupe 1"/>
          <p:cNvGrpSpPr/>
          <p:nvPr/>
        </p:nvGrpSpPr>
        <p:grpSpPr>
          <a:xfrm>
            <a:off x="3435739" y="612651"/>
            <a:ext cx="1972728" cy="1585008"/>
            <a:chOff x="2486977" y="869434"/>
            <a:chExt cx="1972728" cy="1585008"/>
          </a:xfrm>
        </p:grpSpPr>
        <p:pic>
          <p:nvPicPr>
            <p:cNvPr id="15" name="Image 14" descr="Une image contenant animal, poisson, regardant, brun&#10;&#10;Description générée automatiquement">
              <a:extLst>
                <a:ext uri="{FF2B5EF4-FFF2-40B4-BE49-F238E27FC236}">
                  <a16:creationId xmlns:a16="http://schemas.microsoft.com/office/drawing/2014/main" id="{F576C136-C85F-46B1-99E6-6D6EDD68E55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2009" b="3131"/>
            <a:stretch/>
          </p:blipFill>
          <p:spPr>
            <a:xfrm>
              <a:off x="2523172" y="869434"/>
              <a:ext cx="1936533" cy="1585008"/>
            </a:xfrm>
            <a:prstGeom prst="rect">
              <a:avLst/>
            </a:prstGeom>
          </p:spPr>
        </p:pic>
        <p:sp>
          <p:nvSpPr>
            <p:cNvPr id="16" name="ZoneTexte 15">
              <a:extLst>
                <a:ext uri="{FF2B5EF4-FFF2-40B4-BE49-F238E27FC236}">
                  <a16:creationId xmlns:a16="http://schemas.microsoft.com/office/drawing/2014/main" id="{DB46D3B3-A586-441C-A4E0-D5C4CB9B5285}"/>
                </a:ext>
              </a:extLst>
            </p:cNvPr>
            <p:cNvSpPr txBox="1"/>
            <p:nvPr/>
          </p:nvSpPr>
          <p:spPr>
            <a:xfrm>
              <a:off x="2486977" y="869434"/>
              <a:ext cx="39195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685800">
                <a:defRPr/>
              </a:pPr>
              <a:r>
                <a:rPr lang="fr-BE" sz="1350" dirty="0" smtClean="0">
                  <a:solidFill>
                    <a:prstClr val="black"/>
                  </a:solidFill>
                  <a:latin typeface="Calibri" panose="020F0502020204030204"/>
                </a:rPr>
                <a:t>(b)</a:t>
              </a:r>
              <a:endParaRPr lang="fr-BE" sz="135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5399155" y="587031"/>
            <a:ext cx="1828800" cy="1636248"/>
            <a:chOff x="4582329" y="869434"/>
            <a:chExt cx="1828800" cy="1636248"/>
          </a:xfrm>
        </p:grpSpPr>
        <p:pic>
          <p:nvPicPr>
            <p:cNvPr id="18" name="Image 17">
              <a:extLst>
                <a:ext uri="{FF2B5EF4-FFF2-40B4-BE49-F238E27FC236}">
                  <a16:creationId xmlns:a16="http://schemas.microsoft.com/office/drawing/2014/main" id="{E4945022-B399-4D13-AB7E-A7D03D18E2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151" r="6884"/>
            <a:stretch/>
          </p:blipFill>
          <p:spPr>
            <a:xfrm>
              <a:off x="4582329" y="869434"/>
              <a:ext cx="1828800" cy="1636248"/>
            </a:xfrm>
            <a:prstGeom prst="rect">
              <a:avLst/>
            </a:prstGeom>
          </p:spPr>
        </p:pic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9B59A8C1-A035-4743-84F7-A31CBFA44E22}"/>
                </a:ext>
              </a:extLst>
            </p:cNvPr>
            <p:cNvSpPr txBox="1"/>
            <p:nvPr/>
          </p:nvSpPr>
          <p:spPr>
            <a:xfrm>
              <a:off x="4600953" y="869434"/>
              <a:ext cx="443034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685800">
                <a:defRPr/>
              </a:pPr>
              <a:r>
                <a:rPr lang="fr-BE" sz="1350" dirty="0" smtClean="0">
                  <a:solidFill>
                    <a:prstClr val="black"/>
                  </a:solidFill>
                  <a:latin typeface="Calibri" panose="020F0502020204030204"/>
                </a:rPr>
                <a:t>(c)</a:t>
              </a:r>
              <a:endParaRPr lang="fr-BE" sz="1350" dirty="0">
                <a:solidFill>
                  <a:prstClr val="black"/>
                </a:solidFill>
                <a:latin typeface="Calibri" panose="020F0502020204030204"/>
              </a:endParaRPr>
            </a:p>
          </p:txBody>
        </p:sp>
      </p:grpSp>
      <p:grpSp>
        <p:nvGrpSpPr>
          <p:cNvPr id="5" name="Groupe 4"/>
          <p:cNvGrpSpPr/>
          <p:nvPr/>
        </p:nvGrpSpPr>
        <p:grpSpPr>
          <a:xfrm>
            <a:off x="2184668" y="2307697"/>
            <a:ext cx="1931927" cy="1623609"/>
            <a:chOff x="6660983" y="871958"/>
            <a:chExt cx="1931927" cy="1623609"/>
          </a:xfrm>
        </p:grpSpPr>
        <p:pic>
          <p:nvPicPr>
            <p:cNvPr id="21" name="Image 20" descr="Une image contenant intérieur, gâteau, tenant, nid d’abeille&#10;&#10;Description générée automatiquement">
              <a:extLst>
                <a:ext uri="{FF2B5EF4-FFF2-40B4-BE49-F238E27FC236}">
                  <a16:creationId xmlns:a16="http://schemas.microsoft.com/office/drawing/2014/main" id="{E45D9759-D11C-431E-9622-5FB5E6361E9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799"/>
            <a:stretch/>
          </p:blipFill>
          <p:spPr>
            <a:xfrm>
              <a:off x="6672262" y="879549"/>
              <a:ext cx="1920648" cy="1616018"/>
            </a:xfrm>
            <a:prstGeom prst="rect">
              <a:avLst/>
            </a:prstGeom>
          </p:spPr>
        </p:pic>
        <p:sp>
          <p:nvSpPr>
            <p:cNvPr id="22" name="ZoneTexte 21">
              <a:extLst>
                <a:ext uri="{FF2B5EF4-FFF2-40B4-BE49-F238E27FC236}">
                  <a16:creationId xmlns:a16="http://schemas.microsoft.com/office/drawing/2014/main" id="{DB46D3B3-A586-441C-A4E0-D5C4CB9B5285}"/>
                </a:ext>
              </a:extLst>
            </p:cNvPr>
            <p:cNvSpPr txBox="1"/>
            <p:nvPr/>
          </p:nvSpPr>
          <p:spPr>
            <a:xfrm>
              <a:off x="6660983" y="871958"/>
              <a:ext cx="391953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685800">
                <a:defRPr/>
              </a:pPr>
              <a:r>
                <a:rPr lang="fr-BE" sz="1350" dirty="0" smtClean="0">
                  <a:solidFill>
                    <a:schemeClr val="bg1"/>
                  </a:solidFill>
                  <a:latin typeface="Calibri" panose="020F0502020204030204"/>
                </a:rPr>
                <a:t>(d)</a:t>
              </a:r>
              <a:endParaRPr lang="fr-BE" sz="1350" dirty="0">
                <a:solidFill>
                  <a:schemeClr val="bg1"/>
                </a:solidFill>
                <a:latin typeface="Calibri" panose="020F0502020204030204"/>
              </a:endParaRPr>
            </a:p>
          </p:txBody>
        </p:sp>
      </p:grpSp>
      <p:grpSp>
        <p:nvGrpSpPr>
          <p:cNvPr id="7" name="Groupe 6"/>
          <p:cNvGrpSpPr/>
          <p:nvPr/>
        </p:nvGrpSpPr>
        <p:grpSpPr>
          <a:xfrm>
            <a:off x="4130374" y="2307697"/>
            <a:ext cx="2016779" cy="1618191"/>
            <a:chOff x="4544442" y="2530378"/>
            <a:chExt cx="2016779" cy="1618191"/>
          </a:xfrm>
        </p:grpSpPr>
        <p:pic>
          <p:nvPicPr>
            <p:cNvPr id="6" name="Image 5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88" r="3361"/>
            <a:stretch/>
          </p:blipFill>
          <p:spPr>
            <a:xfrm>
              <a:off x="4572000" y="2530378"/>
              <a:ext cx="1989221" cy="1618191"/>
            </a:xfrm>
            <a:prstGeom prst="rect">
              <a:avLst/>
            </a:prstGeom>
          </p:spPr>
        </p:pic>
        <p:sp>
          <p:nvSpPr>
            <p:cNvPr id="27" name="ZoneTexte 26">
              <a:extLst>
                <a:ext uri="{FF2B5EF4-FFF2-40B4-BE49-F238E27FC236}">
                  <a16:creationId xmlns:a16="http://schemas.microsoft.com/office/drawing/2014/main" id="{DB46D3B3-A586-441C-A4E0-D5C4CB9B5285}"/>
                </a:ext>
              </a:extLst>
            </p:cNvPr>
            <p:cNvSpPr txBox="1"/>
            <p:nvPr/>
          </p:nvSpPr>
          <p:spPr>
            <a:xfrm>
              <a:off x="4544442" y="2543582"/>
              <a:ext cx="417478" cy="30008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685800">
                <a:defRPr/>
              </a:pPr>
              <a:r>
                <a:rPr lang="fr-BE" sz="1350" dirty="0" smtClean="0">
                  <a:solidFill>
                    <a:schemeClr val="bg1"/>
                  </a:solidFill>
                  <a:latin typeface="Calibri" panose="020F0502020204030204"/>
                </a:rPr>
                <a:t>(e)</a:t>
              </a:r>
              <a:endParaRPr lang="fr-BE" sz="1350" dirty="0">
                <a:solidFill>
                  <a:schemeClr val="bg1"/>
                </a:solidFill>
                <a:latin typeface="Calibri" panose="020F0502020204030204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12697505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24</TotalTime>
  <Words>88</Words>
  <Application>Microsoft Office PowerPoint</Application>
  <PresentationFormat>Affichage à l'écran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U.L.B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c Behr</dc:creator>
  <cp:lastModifiedBy>marie baucher</cp:lastModifiedBy>
  <cp:revision>21</cp:revision>
  <dcterms:created xsi:type="dcterms:W3CDTF">2020-05-14T09:53:10Z</dcterms:created>
  <dcterms:modified xsi:type="dcterms:W3CDTF">2020-06-25T07:22:11Z</dcterms:modified>
</cp:coreProperties>
</file>